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81092"/>
  </p:normalViewPr>
  <p:slideViewPr>
    <p:cSldViewPr snapToGrid="0" snapToObjects="1">
      <p:cViewPr>
        <p:scale>
          <a:sx n="147" d="100"/>
          <a:sy n="147" d="100"/>
        </p:scale>
        <p:origin x="136" y="-1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299FBB-85DD-DE4E-BE08-8683517367BD}" type="datetimeFigureOut">
              <a:rPr lang="en-US" smtClean="0"/>
              <a:t>5/30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1B986F-2E04-C749-A79B-58DBD6AE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065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FC37A0-8B67-274F-9322-1B0AD260990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651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37AAE-1894-054A-B6CB-F20598F120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381A52B-C85D-B246-905A-E992D62F3C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B8C0AC-B01C-664D-B79D-393F7D7B0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54814B-F11A-E447-B416-DFA53D0B3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75C5B6-BEAC-BC4E-B485-F990E273D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123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EC7A8-3C1C-5E43-BC46-3DD457395A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F65D31-D28B-B944-B355-A7CB9F3274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44B84B-1192-AA46-AAFF-B59650323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A18F99-569C-9F45-9D10-B83449906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CCE33B-CEE7-624E-850A-89D440753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2700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E01466-D85A-4643-9910-F97F008A37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06F78E-3DE8-DB4C-B331-9863BBC004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E56F90-B34D-084B-BC64-75EA3FEC0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DB2BB9-05D2-654A-A59D-98D4EC555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39721C-C75C-F64D-B379-DDF0C0A70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393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2D4959-400B-9247-804B-8559858AB1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090CE1-6DC7-CC42-80A2-8FC599D515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D4C170-FC6A-FD47-B3BB-3E089ED33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5F92CE-95C4-2C48-9151-80BA36896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DC2AF9-D7DA-6341-854C-B4162AE67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169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1402B7-96EE-9B47-8055-A61D614760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880377-4EBA-A948-B4AD-E465086973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B5FE0F-7081-994C-A749-FD558CDB8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26FCA8-1898-D24F-BC74-2045951EB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BFBA90-D3C7-204E-A04D-1465AFD8F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0030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37FB3A-5A2F-A24F-98AD-5F83B224F3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2D13C7-5509-5F43-89B7-F009F79F3C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9491B6-BB9C-F149-98E0-F1DA3B149A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0F4C19-641F-E146-85C9-0A36164C9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7CA67A-C893-7D49-8722-412406A74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1101A4-6971-6841-AE5A-9D2BFE846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544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2F16F7-E1A7-F043-BBBD-0B2A4AE0FE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8DF460-7880-AE42-899E-52CEADA568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1FD108-1026-7543-AC1B-988479CBEC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8B656B-0EBD-7A4F-9B24-A76232916E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386536-DFBB-4345-8AC9-4AAA109A63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9031B9-6777-1F49-A458-753E1FA16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5C245AC-380A-944B-BDD4-B75325B7C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AC02FA-58D2-3A46-A138-98161B934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097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F0EC27-613A-8545-BFC4-35A0BF1BF4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2F51BF-7CC6-D045-9597-F53406AF5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62A33D4-7BA8-784B-BE47-3FF5A67B8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9007A4-2CE7-3B41-B0B8-7F36965F48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402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61A3A5-5768-A74A-8462-A489A946D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6248C90-E6CC-F34D-8E68-7C1B05A3C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0DC392-7B61-D64E-9C0E-95B49C602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599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E4818-0D9C-F44E-95AF-8E134AD310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244E4A-3A77-4F46-92CE-AA5192F44A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304E61-8812-E549-849C-7F9D6687A1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ADEF6-151A-1D40-91F0-6D245B1908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949C20-276D-FB4B-B05B-2776C1D376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5FF201-DA08-BE4E-A34A-E7F30B5BA6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237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9ED146-5AB2-1340-AD47-FA46AA1712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8D3E87A-017A-D640-8571-577376B6E8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0ACFF8-1A40-914E-8038-CBA86821D6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5B3A2F-2F59-114D-B256-6AF10F6CD3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B72376-D29D-FB41-843B-07F83B1738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26AEA9-F59C-D24E-A172-A217DDDE49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370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84DCD9-69DB-1849-9F55-340BE3CBA3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8875F6-CF96-B74E-94DC-6132D6B846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32E8B3-73D2-F84F-9A78-176D328701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0B686-6B01-934F-B1B6-49995CDEED6A}" type="datetimeFigureOut">
              <a:rPr lang="en-US" smtClean="0"/>
              <a:t>5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77EB51-2A34-7443-8AE3-53BE67D9F2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643F36-581D-8943-81B5-F3E7D747EB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957D35-4DFB-804E-B754-BD5D07F713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251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EEF9034-4CC2-5747-AE90-486C5655504B}"/>
              </a:ext>
            </a:extLst>
          </p:cNvPr>
          <p:cNvSpPr txBox="1"/>
          <p:nvPr/>
        </p:nvSpPr>
        <p:spPr>
          <a:xfrm>
            <a:off x="1805069" y="2190784"/>
            <a:ext cx="8498691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Sequences used for protein alignments:</a:t>
            </a:r>
          </a:p>
          <a:p>
            <a:r>
              <a:rPr lang="en-US" dirty="0"/>
              <a:t>&gt;HSF-1 </a:t>
            </a:r>
            <a:r>
              <a:rPr lang="en-US" i="1" dirty="0"/>
              <a:t>Caenorhabditis elegans</a:t>
            </a:r>
          </a:p>
          <a:p>
            <a:r>
              <a:rPr lang="en-US" dirty="0"/>
              <a:t>&gt;gi|1322586|emb|CAA96777.1| HSF1 [Saccharomyces cerevisiae]</a:t>
            </a:r>
          </a:p>
          <a:p>
            <a:r>
              <a:rPr lang="en-US" dirty="0"/>
              <a:t>&gt;gi|5031767|ref|NP_005517.1| heat shock factor protein 1 [Homo sapiens]</a:t>
            </a:r>
          </a:p>
          <a:p>
            <a:r>
              <a:rPr lang="en-US" dirty="0"/>
              <a:t>&gt;gi|7302669|gb|AAF57749.1| heat shock factor, isoform A [Drosophila melanogaster]</a:t>
            </a:r>
          </a:p>
          <a:p>
            <a:r>
              <a:rPr lang="en-US" dirty="0"/>
              <a:t>&gt;gi|33859480|ref|NP_032322.1| heat shock factor protein 1 [Mus musculus]</a:t>
            </a:r>
          </a:p>
          <a:p>
            <a:r>
              <a:rPr lang="en-US" dirty="0"/>
              <a:t>&gt;gi|148222337|ref|NP_001090266.1| heat shock transcription factor 1 [Xenopus </a:t>
            </a:r>
            <a:r>
              <a:rPr lang="en-US" dirty="0" err="1"/>
              <a:t>laevis</a:t>
            </a:r>
            <a:r>
              <a:rPr lang="en-US" dirty="0"/>
              <a:t>]</a:t>
            </a:r>
          </a:p>
          <a:p>
            <a:r>
              <a:rPr lang="en-US" dirty="0"/>
              <a:t>&gt;gi|510946829|gb|AGN53400.1| heat shock factor 1 [</a:t>
            </a:r>
            <a:r>
              <a:rPr lang="en-US" dirty="0" err="1"/>
              <a:t>Haliotis</a:t>
            </a:r>
            <a:r>
              <a:rPr lang="en-US" dirty="0"/>
              <a:t> </a:t>
            </a:r>
            <a:r>
              <a:rPr lang="en-US" dirty="0" err="1"/>
              <a:t>diversicolor</a:t>
            </a:r>
            <a:r>
              <a:rPr lang="en-US" dirty="0"/>
              <a:t>]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453ED75-4778-CB4C-A586-EAB49A6889AD}"/>
              </a:ext>
            </a:extLst>
          </p:cNvPr>
          <p:cNvSpPr txBox="1"/>
          <p:nvPr/>
        </p:nvSpPr>
        <p:spPr>
          <a:xfrm>
            <a:off x="629920" y="508000"/>
            <a:ext cx="8859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le 1. Protein alignments of </a:t>
            </a:r>
            <a:r>
              <a:rPr lang="en-US" i="1" dirty="0"/>
              <a:t>C. elegans </a:t>
            </a:r>
            <a:r>
              <a:rPr lang="en-US" dirty="0"/>
              <a:t>HSF-1 to evolutionarily diverse species </a:t>
            </a:r>
          </a:p>
        </p:txBody>
      </p:sp>
    </p:spTree>
    <p:extLst>
      <p:ext uri="{BB962C8B-B14F-4D97-AF65-F5344CB8AC3E}">
        <p14:creationId xmlns:p14="http://schemas.microsoft.com/office/powerpoint/2010/main" val="25146458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creen Shot 2014-02-05 at 1.20.10 P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348" y="331029"/>
            <a:ext cx="6944868" cy="1354836"/>
          </a:xfrm>
          <a:prstGeom prst="rect">
            <a:avLst/>
          </a:prstGeom>
        </p:spPr>
      </p:pic>
      <p:pic>
        <p:nvPicPr>
          <p:cNvPr id="6" name="Picture 5" descr="Screen Shot 2014-02-05 at 1.20.30 PM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348" y="1761996"/>
            <a:ext cx="7051548" cy="1344168"/>
          </a:xfrm>
          <a:prstGeom prst="rect">
            <a:avLst/>
          </a:prstGeom>
        </p:spPr>
      </p:pic>
      <p:pic>
        <p:nvPicPr>
          <p:cNvPr id="7" name="Picture 6" descr="Screen Shot 2014-02-05 at 1.20.45 PM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348" y="3172422"/>
            <a:ext cx="7019544" cy="1333500"/>
          </a:xfrm>
          <a:prstGeom prst="rect">
            <a:avLst/>
          </a:prstGeom>
        </p:spPr>
      </p:pic>
      <p:pic>
        <p:nvPicPr>
          <p:cNvPr id="8" name="Picture 7" descr="Screen Shot 2014-02-05 at 1.21.29 PM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348" y="4666422"/>
            <a:ext cx="6998208" cy="134416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292145" y="1667586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2270059" y="3080875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2314231" y="246841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2270059" y="4582509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5" name="Rectangle 14"/>
          <p:cNvSpPr/>
          <p:nvPr/>
        </p:nvSpPr>
        <p:spPr>
          <a:xfrm>
            <a:off x="8800362" y="3148229"/>
            <a:ext cx="112386" cy="1472625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6783824" y="4582508"/>
            <a:ext cx="216466" cy="1491582"/>
          </a:xfrm>
          <a:prstGeom prst="rect">
            <a:avLst/>
          </a:prstGeom>
          <a:noFill/>
          <a:ln>
            <a:solidFill>
              <a:srgbClr val="7F7F7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9725345" y="3156239"/>
            <a:ext cx="112386" cy="1472625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8695524" y="6427114"/>
            <a:ext cx="1593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00FF"/>
                </a:solidFill>
              </a:rPr>
              <a:t>Acetylated lysine (humans)</a:t>
            </a:r>
          </a:p>
        </p:txBody>
      </p:sp>
      <p:sp>
        <p:nvSpPr>
          <p:cNvPr id="17" name="Rectangle 16"/>
          <p:cNvSpPr/>
          <p:nvPr/>
        </p:nvSpPr>
        <p:spPr>
          <a:xfrm>
            <a:off x="6632895" y="4583058"/>
            <a:ext cx="112386" cy="1472625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6483350" y="4398603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0000FF"/>
                </a:solidFill>
              </a:rPr>
              <a:t>lys118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9568210" y="2967731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0000FF"/>
                </a:solidFill>
              </a:rPr>
              <a:t>lys80</a:t>
            </a:r>
          </a:p>
        </p:txBody>
      </p:sp>
      <p:sp>
        <p:nvSpPr>
          <p:cNvPr id="19" name="Rectangle 18"/>
          <p:cNvSpPr/>
          <p:nvPr/>
        </p:nvSpPr>
        <p:spPr>
          <a:xfrm>
            <a:off x="6474145" y="4583058"/>
            <a:ext cx="112386" cy="1472625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6191625" y="4392481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0000FF"/>
                </a:solidFill>
              </a:rPr>
              <a:t>lys116</a:t>
            </a:r>
          </a:p>
        </p:txBody>
      </p:sp>
      <p:sp>
        <p:nvSpPr>
          <p:cNvPr id="21" name="Rectangle 20"/>
          <p:cNvSpPr/>
          <p:nvPr/>
        </p:nvSpPr>
        <p:spPr>
          <a:xfrm>
            <a:off x="4391345" y="4601466"/>
            <a:ext cx="112386" cy="1472625"/>
          </a:xfrm>
          <a:prstGeom prst="rect">
            <a:avLst/>
          </a:prstGeom>
          <a:noFill/>
          <a:ln>
            <a:solidFill>
              <a:srgbClr val="660066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660066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089400" y="4426119"/>
            <a:ext cx="74075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660066"/>
                </a:solidFill>
              </a:rPr>
              <a:t>lys82 of HSF2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695524" y="6577771"/>
            <a:ext cx="1217163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660066"/>
                </a:solidFill>
              </a:rPr>
              <a:t>SUMO lysine (HSF2)</a:t>
            </a:r>
          </a:p>
        </p:txBody>
      </p:sp>
      <p:sp>
        <p:nvSpPr>
          <p:cNvPr id="27" name="Rectangle 26"/>
          <p:cNvSpPr/>
          <p:nvPr/>
        </p:nvSpPr>
        <p:spPr>
          <a:xfrm>
            <a:off x="4830158" y="3140211"/>
            <a:ext cx="5140726" cy="1365712"/>
          </a:xfrm>
          <a:prstGeom prst="rect">
            <a:avLst/>
          </a:prstGeom>
          <a:solidFill>
            <a:schemeClr val="accent5">
              <a:lumMod val="20000"/>
              <a:lumOff val="8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7348874" y="1730561"/>
            <a:ext cx="2622011" cy="1365712"/>
          </a:xfrm>
          <a:prstGeom prst="rect">
            <a:avLst/>
          </a:prstGeom>
          <a:solidFill>
            <a:schemeClr val="accent5">
              <a:lumMod val="20000"/>
              <a:lumOff val="8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3772023" y="4658323"/>
            <a:ext cx="2327914" cy="1365712"/>
          </a:xfrm>
          <a:prstGeom prst="rect">
            <a:avLst/>
          </a:prstGeom>
          <a:solidFill>
            <a:schemeClr val="accent5">
              <a:lumMod val="20000"/>
              <a:lumOff val="8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4503732" y="6055682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BD</a:t>
            </a:r>
          </a:p>
        </p:txBody>
      </p:sp>
    </p:spTree>
    <p:extLst>
      <p:ext uri="{BB962C8B-B14F-4D97-AF65-F5344CB8AC3E}">
        <p14:creationId xmlns:p14="http://schemas.microsoft.com/office/powerpoint/2010/main" val="11557597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creen Shot 2014-02-05 at 1.23.14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1674" y="331875"/>
            <a:ext cx="6987540" cy="1365504"/>
          </a:xfrm>
          <a:prstGeom prst="rect">
            <a:avLst/>
          </a:prstGeom>
        </p:spPr>
      </p:pic>
      <p:pic>
        <p:nvPicPr>
          <p:cNvPr id="3" name="Picture 2" descr="Screen Shot 2014-02-05 at 1.23.36 P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1006" y="1740759"/>
            <a:ext cx="7008876" cy="1354836"/>
          </a:xfrm>
          <a:prstGeom prst="rect">
            <a:avLst/>
          </a:prstGeom>
        </p:spPr>
      </p:pic>
      <p:pic>
        <p:nvPicPr>
          <p:cNvPr id="4" name="Picture 3" descr="Screen Shot 2014-02-05 at 1.23.53 PM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6340" y="3560148"/>
            <a:ext cx="6998208" cy="1312164"/>
          </a:xfrm>
          <a:prstGeom prst="rect">
            <a:avLst/>
          </a:prstGeom>
        </p:spPr>
      </p:pic>
      <p:pic>
        <p:nvPicPr>
          <p:cNvPr id="13" name="Picture 12" descr="Screen Shot 2014-02-05 at 1.24.09 PM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1006" y="5068134"/>
            <a:ext cx="7008876" cy="1376172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292145" y="1667586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2270059" y="3472343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2314231" y="246841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2270059" y="4973977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4" name="Rectangle 13"/>
          <p:cNvSpPr/>
          <p:nvPr/>
        </p:nvSpPr>
        <p:spPr>
          <a:xfrm>
            <a:off x="6442898" y="3495462"/>
            <a:ext cx="112386" cy="1357755"/>
          </a:xfrm>
          <a:prstGeom prst="rect">
            <a:avLst/>
          </a:prstGeom>
          <a:noFill/>
          <a:ln>
            <a:solidFill>
              <a:srgbClr val="000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5909244" y="3237559"/>
            <a:ext cx="23117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srgbClr val="000090"/>
                </a:solidFill>
              </a:rPr>
              <a:t>P site in elegans = S221 in humans</a:t>
            </a:r>
          </a:p>
        </p:txBody>
      </p:sp>
      <p:sp>
        <p:nvSpPr>
          <p:cNvPr id="16" name="Rectangle 15"/>
          <p:cNvSpPr/>
          <p:nvPr/>
        </p:nvSpPr>
        <p:spPr>
          <a:xfrm>
            <a:off x="7211073" y="3514558"/>
            <a:ext cx="112386" cy="1357755"/>
          </a:xfrm>
          <a:prstGeom prst="rect">
            <a:avLst/>
          </a:prstGeom>
          <a:noFill/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6752174" y="3134348"/>
            <a:ext cx="10351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H: S230 missing</a:t>
            </a:r>
          </a:p>
        </p:txBody>
      </p:sp>
      <p:sp>
        <p:nvSpPr>
          <p:cNvPr id="18" name="Rectangle 17"/>
          <p:cNvSpPr/>
          <p:nvPr/>
        </p:nvSpPr>
        <p:spPr>
          <a:xfrm>
            <a:off x="7820673" y="4947118"/>
            <a:ext cx="112386" cy="1472625"/>
          </a:xfrm>
          <a:prstGeom prst="rect">
            <a:avLst/>
          </a:prstGeom>
          <a:noFill/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6062993" y="3484078"/>
            <a:ext cx="112386" cy="1357755"/>
          </a:xfrm>
          <a:prstGeom prst="rect">
            <a:avLst/>
          </a:prstGeom>
          <a:noFill/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5289157" y="375047"/>
            <a:ext cx="4736009" cy="1365712"/>
          </a:xfrm>
          <a:prstGeom prst="rect">
            <a:avLst/>
          </a:prstGeom>
          <a:solidFill>
            <a:schemeClr val="accent5">
              <a:lumMod val="20000"/>
              <a:lumOff val="8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126699" y="1740759"/>
            <a:ext cx="1781373" cy="1365712"/>
          </a:xfrm>
          <a:prstGeom prst="rect">
            <a:avLst/>
          </a:prstGeom>
          <a:solidFill>
            <a:schemeClr val="accent5">
              <a:lumMod val="20000"/>
              <a:lumOff val="8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6230857" y="20190"/>
            <a:ext cx="394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R-A/B region (oligomerization domain)</a:t>
            </a:r>
          </a:p>
        </p:txBody>
      </p:sp>
      <p:sp>
        <p:nvSpPr>
          <p:cNvPr id="24" name="Rectangle 23"/>
          <p:cNvSpPr/>
          <p:nvPr/>
        </p:nvSpPr>
        <p:spPr>
          <a:xfrm>
            <a:off x="6062994" y="3472342"/>
            <a:ext cx="3962172" cy="1365712"/>
          </a:xfrm>
          <a:prstGeom prst="rect">
            <a:avLst/>
          </a:prstGeom>
          <a:solidFill>
            <a:schemeClr val="accent5">
              <a:lumMod val="20000"/>
              <a:lumOff val="8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8286594" y="3052892"/>
            <a:ext cx="2381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D (regulatory domain)</a:t>
            </a:r>
          </a:p>
        </p:txBody>
      </p:sp>
      <p:sp>
        <p:nvSpPr>
          <p:cNvPr id="25" name="Rectangle 24"/>
          <p:cNvSpPr/>
          <p:nvPr/>
        </p:nvSpPr>
        <p:spPr>
          <a:xfrm>
            <a:off x="3780483" y="5068134"/>
            <a:ext cx="6244684" cy="1365712"/>
          </a:xfrm>
          <a:prstGeom prst="rect">
            <a:avLst/>
          </a:prstGeom>
          <a:solidFill>
            <a:schemeClr val="accent5">
              <a:lumMod val="20000"/>
              <a:lumOff val="8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9362516" y="5068135"/>
            <a:ext cx="112386" cy="1472625"/>
          </a:xfrm>
          <a:prstGeom prst="rect">
            <a:avLst/>
          </a:prstGeom>
          <a:noFill/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8950589" y="5459356"/>
            <a:ext cx="158306" cy="176966"/>
          </a:xfrm>
          <a:prstGeom prst="rect">
            <a:avLst/>
          </a:prstGeom>
          <a:noFill/>
          <a:ln>
            <a:solidFill>
              <a:srgbClr val="660066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660066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723988" y="6601552"/>
            <a:ext cx="19440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660066"/>
                </a:solidFill>
              </a:rPr>
              <a:t>K298 = Sumo site in humans</a:t>
            </a:r>
          </a:p>
        </p:txBody>
      </p:sp>
    </p:spTree>
    <p:extLst>
      <p:ext uri="{BB962C8B-B14F-4D97-AF65-F5344CB8AC3E}">
        <p14:creationId xmlns:p14="http://schemas.microsoft.com/office/powerpoint/2010/main" val="31241232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creen Shot 2014-02-05 at 1.25.28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5305" y="315292"/>
            <a:ext cx="6998208" cy="1344168"/>
          </a:xfrm>
          <a:prstGeom prst="rect">
            <a:avLst/>
          </a:prstGeom>
        </p:spPr>
      </p:pic>
      <p:pic>
        <p:nvPicPr>
          <p:cNvPr id="6" name="Picture 5" descr="Screen Shot 2014-02-05 at 1.25.46 P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9303" y="1766683"/>
            <a:ext cx="7030212" cy="1354836"/>
          </a:xfrm>
          <a:prstGeom prst="rect">
            <a:avLst/>
          </a:prstGeom>
        </p:spPr>
      </p:pic>
      <p:pic>
        <p:nvPicPr>
          <p:cNvPr id="7" name="Picture 6" descr="Screen Shot 2014-02-05 at 1.26.02 PM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3219" y="3205642"/>
            <a:ext cx="6998208" cy="1312164"/>
          </a:xfrm>
          <a:prstGeom prst="rect">
            <a:avLst/>
          </a:prstGeom>
        </p:spPr>
      </p:pic>
      <p:pic>
        <p:nvPicPr>
          <p:cNvPr id="8" name="Picture 7" descr="Screen Shot 2014-02-05 at 1.26.18 PM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8553" y="4672769"/>
            <a:ext cx="6987540" cy="13335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292145" y="1667586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2270059" y="3080875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2314231" y="246841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2270059" y="4582509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13" name="Rectangle 12"/>
          <p:cNvSpPr/>
          <p:nvPr/>
        </p:nvSpPr>
        <p:spPr>
          <a:xfrm>
            <a:off x="9395473" y="3070715"/>
            <a:ext cx="112386" cy="1472625"/>
          </a:xfrm>
          <a:prstGeom prst="rect">
            <a:avLst/>
          </a:prstGeom>
          <a:noFill/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3817008" y="293748"/>
            <a:ext cx="6187166" cy="1365712"/>
          </a:xfrm>
          <a:prstGeom prst="rect">
            <a:avLst/>
          </a:prstGeom>
          <a:solidFill>
            <a:schemeClr val="accent5">
              <a:lumMod val="20000"/>
              <a:lumOff val="8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3817008" y="1745466"/>
            <a:ext cx="6187166" cy="1365712"/>
          </a:xfrm>
          <a:prstGeom prst="rect">
            <a:avLst/>
          </a:prstGeom>
          <a:solidFill>
            <a:schemeClr val="accent5">
              <a:lumMod val="20000"/>
              <a:lumOff val="8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3827503" y="3216796"/>
            <a:ext cx="2902148" cy="1365712"/>
          </a:xfrm>
          <a:prstGeom prst="rect">
            <a:avLst/>
          </a:prstGeom>
          <a:solidFill>
            <a:schemeClr val="accent5">
              <a:lumMod val="20000"/>
              <a:lumOff val="8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9550204" y="-19029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D</a:t>
            </a:r>
          </a:p>
        </p:txBody>
      </p:sp>
      <p:sp>
        <p:nvSpPr>
          <p:cNvPr id="17" name="Rectangle 16"/>
          <p:cNvSpPr/>
          <p:nvPr/>
        </p:nvSpPr>
        <p:spPr>
          <a:xfrm>
            <a:off x="6719156" y="3216796"/>
            <a:ext cx="1999394" cy="1365712"/>
          </a:xfrm>
          <a:prstGeom prst="rect">
            <a:avLst/>
          </a:prstGeom>
          <a:solidFill>
            <a:schemeClr val="accent2">
              <a:lumMod val="60000"/>
              <a:lumOff val="4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7143750" y="2953359"/>
            <a:ext cx="10519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R-C region</a:t>
            </a:r>
          </a:p>
        </p:txBody>
      </p:sp>
      <p:sp>
        <p:nvSpPr>
          <p:cNvPr id="18" name="Rectangle 17"/>
          <p:cNvSpPr/>
          <p:nvPr/>
        </p:nvSpPr>
        <p:spPr>
          <a:xfrm>
            <a:off x="8718550" y="3216796"/>
            <a:ext cx="1285624" cy="1365712"/>
          </a:xfrm>
          <a:prstGeom prst="rect">
            <a:avLst/>
          </a:prstGeom>
          <a:solidFill>
            <a:schemeClr val="tx2">
              <a:lumMod val="40000"/>
              <a:lumOff val="6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8908979" y="2954572"/>
            <a:ext cx="4864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AD</a:t>
            </a:r>
          </a:p>
        </p:txBody>
      </p:sp>
      <p:sp>
        <p:nvSpPr>
          <p:cNvPr id="19" name="Rectangle 18"/>
          <p:cNvSpPr/>
          <p:nvPr/>
        </p:nvSpPr>
        <p:spPr>
          <a:xfrm>
            <a:off x="3785523" y="4672769"/>
            <a:ext cx="6187166" cy="1365712"/>
          </a:xfrm>
          <a:prstGeom prst="rect">
            <a:avLst/>
          </a:prstGeom>
          <a:solidFill>
            <a:schemeClr val="tx2">
              <a:lumMod val="40000"/>
              <a:lumOff val="6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1" name="Straight Connector 20"/>
          <p:cNvCxnSpPr/>
          <p:nvPr/>
        </p:nvCxnSpPr>
        <p:spPr>
          <a:xfrm>
            <a:off x="8031096" y="3715679"/>
            <a:ext cx="15292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5982704" y="6581002"/>
            <a:ext cx="4685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 Black line = TAD1: interacts with basal transcriptional component TAF-9</a:t>
            </a:r>
          </a:p>
        </p:txBody>
      </p:sp>
      <p:sp>
        <p:nvSpPr>
          <p:cNvPr id="23" name="Oval 22"/>
          <p:cNvSpPr/>
          <p:nvPr/>
        </p:nvSpPr>
        <p:spPr>
          <a:xfrm>
            <a:off x="8426437" y="3160994"/>
            <a:ext cx="202708" cy="202708"/>
          </a:xfrm>
          <a:prstGeom prst="ellipse">
            <a:avLst/>
          </a:prstGeom>
          <a:noFill/>
          <a:ln w="19050" cmpd="sng">
            <a:solidFill>
              <a:srgbClr val="000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Oval 23"/>
          <p:cNvSpPr/>
          <p:nvPr/>
        </p:nvSpPr>
        <p:spPr>
          <a:xfrm>
            <a:off x="6071957" y="6388789"/>
            <a:ext cx="202708" cy="202708"/>
          </a:xfrm>
          <a:prstGeom prst="ellipse">
            <a:avLst/>
          </a:prstGeom>
          <a:noFill/>
          <a:ln w="19050" cmpd="sng">
            <a:solidFill>
              <a:srgbClr val="000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/>
          <p:cNvSpPr txBox="1"/>
          <p:nvPr/>
        </p:nvSpPr>
        <p:spPr>
          <a:xfrm>
            <a:off x="6222191" y="6318756"/>
            <a:ext cx="16881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= sy441 W585amber</a:t>
            </a:r>
          </a:p>
        </p:txBody>
      </p:sp>
    </p:spTree>
    <p:extLst>
      <p:ext uri="{BB962C8B-B14F-4D97-AF65-F5344CB8AC3E}">
        <p14:creationId xmlns:p14="http://schemas.microsoft.com/office/powerpoint/2010/main" val="10956613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creen Shot 2014-02-05 at 1.26.47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3749" y="326337"/>
            <a:ext cx="3339084" cy="1344168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314231" y="246841"/>
            <a:ext cx="1206163" cy="14314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S. cerevisiae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H. sapiens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D. melanogaster</a:t>
            </a:r>
          </a:p>
          <a:p>
            <a:pPr algn="r">
              <a:lnSpc>
                <a:spcPts val="1500"/>
              </a:lnSpc>
            </a:pPr>
            <a:r>
              <a:rPr lang="en-US" sz="1200" i="1" dirty="0"/>
              <a:t>M. </a:t>
            </a:r>
            <a:r>
              <a:rPr lang="en-US" sz="1200" i="1" dirty="0" err="1"/>
              <a:t>musculu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X. </a:t>
            </a:r>
            <a:r>
              <a:rPr lang="en-US" sz="1200" i="1" dirty="0" err="1"/>
              <a:t>laevis</a:t>
            </a:r>
            <a:endParaRPr lang="en-US" sz="1200" i="1" dirty="0"/>
          </a:p>
          <a:p>
            <a:pPr algn="r">
              <a:lnSpc>
                <a:spcPts val="1500"/>
              </a:lnSpc>
            </a:pPr>
            <a:r>
              <a:rPr lang="en-US" sz="1200" i="1" dirty="0"/>
              <a:t>H. </a:t>
            </a:r>
            <a:r>
              <a:rPr lang="en-US" sz="1200" i="1" dirty="0" err="1"/>
              <a:t>divericolor</a:t>
            </a:r>
            <a:endParaRPr lang="en-US" sz="1200" i="1" dirty="0"/>
          </a:p>
        </p:txBody>
      </p:sp>
      <p:sp>
        <p:nvSpPr>
          <p:cNvPr id="5" name="Rectangle 4"/>
          <p:cNvSpPr/>
          <p:nvPr/>
        </p:nvSpPr>
        <p:spPr>
          <a:xfrm>
            <a:off x="3841750" y="326337"/>
            <a:ext cx="2540000" cy="1365712"/>
          </a:xfrm>
          <a:prstGeom prst="rect">
            <a:avLst/>
          </a:prstGeom>
          <a:solidFill>
            <a:schemeClr val="tx2">
              <a:lumMod val="40000"/>
              <a:lumOff val="60000"/>
              <a:alpha val="2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180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76</Words>
  <Application>Microsoft Macintosh PowerPoint</Application>
  <PresentationFormat>Widescreen</PresentationFormat>
  <Paragraphs>118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uelson, Andrew</dc:creator>
  <cp:lastModifiedBy>Samuelson, Andrew</cp:lastModifiedBy>
  <cp:revision>2</cp:revision>
  <dcterms:created xsi:type="dcterms:W3CDTF">2022-01-23T19:52:37Z</dcterms:created>
  <dcterms:modified xsi:type="dcterms:W3CDTF">2022-05-31T02:08:41Z</dcterms:modified>
</cp:coreProperties>
</file>